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70" r:id="rId5"/>
    <p:sldId id="268" r:id="rId6"/>
    <p:sldId id="269" r:id="rId7"/>
    <p:sldId id="272" r:id="rId8"/>
    <p:sldId id="273" r:id="rId9"/>
    <p:sldId id="266" r:id="rId10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F1A2C63-B557-4747-8DB4-CB3DEF56CCF4}" v="3" dt="2020-06-25T16:47:41.89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717" autoAdjust="0"/>
  </p:normalViewPr>
  <p:slideViewPr>
    <p:cSldViewPr snapToGrid="0">
      <p:cViewPr varScale="1">
        <p:scale>
          <a:sx n="45" d="100"/>
          <a:sy n="45" d="100"/>
        </p:scale>
        <p:origin x="217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5/10/relationships/revisionInfo" Target="revisionInfo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5EDE9-284D-4D55-A80D-7839ACD9E113}" type="datetimeFigureOut">
              <a:rPr lang="en-US" smtClean="0"/>
              <a:t>6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F514F-AA3F-43AD-8CC8-1B512878B9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701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5EDE9-284D-4D55-A80D-7839ACD9E113}" type="datetimeFigureOut">
              <a:rPr lang="en-US" smtClean="0"/>
              <a:t>6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F514F-AA3F-43AD-8CC8-1B512878B9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087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5EDE9-284D-4D55-A80D-7839ACD9E113}" type="datetimeFigureOut">
              <a:rPr lang="en-US" smtClean="0"/>
              <a:t>6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F514F-AA3F-43AD-8CC8-1B512878B9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443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5EDE9-284D-4D55-A80D-7839ACD9E113}" type="datetimeFigureOut">
              <a:rPr lang="en-US" smtClean="0"/>
              <a:t>6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F514F-AA3F-43AD-8CC8-1B512878B9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989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5EDE9-284D-4D55-A80D-7839ACD9E113}" type="datetimeFigureOut">
              <a:rPr lang="en-US" smtClean="0"/>
              <a:t>6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F514F-AA3F-43AD-8CC8-1B512878B9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621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5EDE9-284D-4D55-A80D-7839ACD9E113}" type="datetimeFigureOut">
              <a:rPr lang="en-US" smtClean="0"/>
              <a:t>6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F514F-AA3F-43AD-8CC8-1B512878B9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855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5EDE9-284D-4D55-A80D-7839ACD9E113}" type="datetimeFigureOut">
              <a:rPr lang="en-US" smtClean="0"/>
              <a:t>6/2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F514F-AA3F-43AD-8CC8-1B512878B9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653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5EDE9-284D-4D55-A80D-7839ACD9E113}" type="datetimeFigureOut">
              <a:rPr lang="en-US" smtClean="0"/>
              <a:t>6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F514F-AA3F-43AD-8CC8-1B512878B9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4018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5EDE9-284D-4D55-A80D-7839ACD9E113}" type="datetimeFigureOut">
              <a:rPr lang="en-US" smtClean="0"/>
              <a:t>6/2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F514F-AA3F-43AD-8CC8-1B512878B9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435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5EDE9-284D-4D55-A80D-7839ACD9E113}" type="datetimeFigureOut">
              <a:rPr lang="en-US" smtClean="0"/>
              <a:t>6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F514F-AA3F-43AD-8CC8-1B512878B9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1488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5EDE9-284D-4D55-A80D-7839ACD9E113}" type="datetimeFigureOut">
              <a:rPr lang="en-US" smtClean="0"/>
              <a:t>6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F514F-AA3F-43AD-8CC8-1B512878B9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44381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C5EDE9-284D-4D55-A80D-7839ACD9E113}" type="datetimeFigureOut">
              <a:rPr lang="en-US" smtClean="0"/>
              <a:t>6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5F514F-AA3F-43AD-8CC8-1B512878B9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9831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7.emf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4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839FEDA-C649-4664-927E-392A865B31D8}"/>
              </a:ext>
            </a:extLst>
          </p:cNvPr>
          <p:cNvSpPr txBox="1"/>
          <p:nvPr/>
        </p:nvSpPr>
        <p:spPr>
          <a:xfrm>
            <a:off x="792480" y="6609160"/>
            <a:ext cx="5493382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 Effect of BTTQ on systolic and diastolic blood pressure of SD rats. Systolic and diastolic blood pressure were recorded for 24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and SD rats were dosed twice daily as shown by dotted lines. Data represented as mean ± SEM. Main effect of BTTQ treated animals is significantly different from vehicle, p&lt;0.0001 for high dose group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D1E8EF3-BB47-418B-BD41-3D83526A812B}"/>
              </a:ext>
            </a:extLst>
          </p:cNvPr>
          <p:cNvSpPr txBox="1"/>
          <p:nvPr/>
        </p:nvSpPr>
        <p:spPr>
          <a:xfrm>
            <a:off x="912350" y="816992"/>
            <a:ext cx="268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2145C7F-F4A4-48FA-8C20-0828B8F1AB94}"/>
              </a:ext>
            </a:extLst>
          </p:cNvPr>
          <p:cNvSpPr txBox="1"/>
          <p:nvPr/>
        </p:nvSpPr>
        <p:spPr>
          <a:xfrm>
            <a:off x="909737" y="3556509"/>
            <a:ext cx="268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B285BB67-F418-42CE-8892-1A26BF2135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94290364"/>
              </p:ext>
            </p:extLst>
          </p:nvPr>
        </p:nvGraphicFramePr>
        <p:xfrm>
          <a:off x="411163" y="1139825"/>
          <a:ext cx="5267325" cy="2436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8" r:id="rId3" imgW="6659269" imgH="3082004" progId="Prism8.Document">
                  <p:embed/>
                </p:oleObj>
              </mc:Choice>
              <mc:Fallback>
                <p:oleObj name="Prism 8" r:id="rId3" imgW="6659269" imgH="3082004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B285BB67-F418-42CE-8892-1A26BF2135A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11163" y="1139825"/>
                        <a:ext cx="5267325" cy="2436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F663E3DF-7DA6-4442-86DB-EB4E454511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622681"/>
              </p:ext>
            </p:extLst>
          </p:nvPr>
        </p:nvGraphicFramePr>
        <p:xfrm>
          <a:off x="409575" y="3925888"/>
          <a:ext cx="5270500" cy="2460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8" r:id="rId5" imgW="6662511" imgH="3110807" progId="Prism8.Document">
                  <p:embed/>
                </p:oleObj>
              </mc:Choice>
              <mc:Fallback>
                <p:oleObj name="Prism 8" r:id="rId5" imgW="6662511" imgH="3110807" progId="Prism8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F663E3DF-7DA6-4442-86DB-EB4E4545115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09575" y="3925888"/>
                        <a:ext cx="5270500" cy="2460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359946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20384CBC-95C7-45E6-A48E-8F27C97D620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0817240"/>
              </p:ext>
            </p:extLst>
          </p:nvPr>
        </p:nvGraphicFramePr>
        <p:xfrm>
          <a:off x="481249" y="3938883"/>
          <a:ext cx="6219000" cy="25072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4" name="Prism 8" r:id="rId3" imgW="7888053" imgH="3077323" progId="Prism8.Document">
                  <p:embed/>
                </p:oleObj>
              </mc:Choice>
              <mc:Fallback>
                <p:oleObj name="Prism 8" r:id="rId3" imgW="7888053" imgH="3077323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20384CBC-95C7-45E6-A48E-8F27C97D620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81249" y="3938883"/>
                        <a:ext cx="6219000" cy="25072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B4E8437D-298D-414A-BA42-22751AB7843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8866847"/>
              </p:ext>
            </p:extLst>
          </p:nvPr>
        </p:nvGraphicFramePr>
        <p:xfrm>
          <a:off x="481249" y="845794"/>
          <a:ext cx="6340475" cy="25754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5" name="Prism 8" r:id="rId5" imgW="7921545" imgH="3110807" progId="Prism8.Document">
                  <p:embed/>
                </p:oleObj>
              </mc:Choice>
              <mc:Fallback>
                <p:oleObj name="Prism 8" r:id="rId5" imgW="7921545" imgH="3110807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B4E8437D-298D-414A-BA42-22751AB7843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81249" y="845794"/>
                        <a:ext cx="6340475" cy="25754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4839FEDA-C649-4664-927E-392A865B31D8}"/>
              </a:ext>
            </a:extLst>
          </p:cNvPr>
          <p:cNvSpPr txBox="1"/>
          <p:nvPr/>
        </p:nvSpPr>
        <p:spPr>
          <a:xfrm>
            <a:off x="736436" y="7013338"/>
            <a:ext cx="5493382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 Effect of BTTQ on systolic and diastolic blood pressure of SHR rats. Systolic and diastolic blood pressure were recorded for 24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and SHR rats were dosed twice daily as shown by dotted lines. Data represented as mean ± SEM. Main effect of BTTQ treated animals is significantly different from vehicle, p&lt;0.0001 for high dose group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4E94509-AD86-4CE0-B53D-F04FB0E600C3}"/>
              </a:ext>
            </a:extLst>
          </p:cNvPr>
          <p:cNvSpPr txBox="1"/>
          <p:nvPr/>
        </p:nvSpPr>
        <p:spPr>
          <a:xfrm>
            <a:off x="213025" y="568795"/>
            <a:ext cx="268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F5401E0-4639-49BE-B4E9-0A85417B3FC1}"/>
              </a:ext>
            </a:extLst>
          </p:cNvPr>
          <p:cNvSpPr txBox="1"/>
          <p:nvPr/>
        </p:nvSpPr>
        <p:spPr>
          <a:xfrm>
            <a:off x="275727" y="3308312"/>
            <a:ext cx="268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5420167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B2DE5C43-CC75-42FC-867F-8EE2B9C76B1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4968640"/>
              </p:ext>
            </p:extLst>
          </p:nvPr>
        </p:nvGraphicFramePr>
        <p:xfrm>
          <a:off x="1839913" y="744538"/>
          <a:ext cx="3475037" cy="2449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8" name="Prism 8" r:id="rId3" imgW="4354041" imgH="3069233" progId="Prism8.Document">
                  <p:embed/>
                </p:oleObj>
              </mc:Choice>
              <mc:Fallback>
                <p:oleObj name="Prism 8" r:id="rId3" imgW="4354041" imgH="3069233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B2DE5C43-CC75-42FC-867F-8EE2B9C76B1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39913" y="744538"/>
                        <a:ext cx="3475037" cy="24495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892D726-1A87-46CE-BD0D-AFD39104548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3230561"/>
              </p:ext>
            </p:extLst>
          </p:nvPr>
        </p:nvGraphicFramePr>
        <p:xfrm>
          <a:off x="1862138" y="3695476"/>
          <a:ext cx="3452812" cy="2487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9" name="Prism 8" r:id="rId5" imgW="4322349" imgH="3114972" progId="Prism8.Document">
                  <p:embed/>
                </p:oleObj>
              </mc:Choice>
              <mc:Fallback>
                <p:oleObj name="Prism 8" r:id="rId5" imgW="4322349" imgH="3114972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5892D726-1A87-46CE-BD0D-AFD39104548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862138" y="3695476"/>
                        <a:ext cx="3452812" cy="2487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F957CAEA-5CA8-4822-B17B-A044AE1F4274}"/>
              </a:ext>
            </a:extLst>
          </p:cNvPr>
          <p:cNvCxnSpPr>
            <a:cxnSpLocks/>
          </p:cNvCxnSpPr>
          <p:nvPr/>
        </p:nvCxnSpPr>
        <p:spPr>
          <a:xfrm>
            <a:off x="3030730" y="976364"/>
            <a:ext cx="0" cy="1666663"/>
          </a:xfrm>
          <a:prstGeom prst="line">
            <a:avLst/>
          </a:prstGeom>
          <a:ln w="19050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8">
            <a:extLst>
              <a:ext uri="{FF2B5EF4-FFF2-40B4-BE49-F238E27FC236}">
                <a16:creationId xmlns:a16="http://schemas.microsoft.com/office/drawing/2014/main" id="{0734C5C5-AD07-4E28-A29A-9F1E63A99D3B}"/>
              </a:ext>
            </a:extLst>
          </p:cNvPr>
          <p:cNvSpPr/>
          <p:nvPr/>
        </p:nvSpPr>
        <p:spPr>
          <a:xfrm>
            <a:off x="2633502" y="976364"/>
            <a:ext cx="363474" cy="230833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>
                <a:lumMod val="20000"/>
                <a:lumOff val="80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750" b="1" dirty="0">
                <a:latin typeface="Arial" panose="020B0604020202020204" pitchFamily="34" charset="0"/>
                <a:cs typeface="Arial" panose="020B0604020202020204" pitchFamily="34" charset="0"/>
              </a:rPr>
              <a:t>0.4% NaCl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23A43349-CF3C-45DE-9558-F5337F107CB0}"/>
              </a:ext>
            </a:extLst>
          </p:cNvPr>
          <p:cNvSpPr/>
          <p:nvPr/>
        </p:nvSpPr>
        <p:spPr>
          <a:xfrm>
            <a:off x="3036054" y="976364"/>
            <a:ext cx="1776563" cy="230833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bg2">
                <a:lumMod val="90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750" b="1" dirty="0">
                <a:latin typeface="Arial" panose="020B0604020202020204" pitchFamily="34" charset="0"/>
                <a:cs typeface="Arial" panose="020B0604020202020204" pitchFamily="34" charset="0"/>
              </a:rPr>
              <a:t>4% NaCl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988F90B0-8BA1-4E00-AABF-E2CA72E645EC}"/>
              </a:ext>
            </a:extLst>
          </p:cNvPr>
          <p:cNvCxnSpPr>
            <a:cxnSpLocks/>
          </p:cNvCxnSpPr>
          <p:nvPr/>
        </p:nvCxnSpPr>
        <p:spPr>
          <a:xfrm>
            <a:off x="3054099" y="3969612"/>
            <a:ext cx="0" cy="1666663"/>
          </a:xfrm>
          <a:prstGeom prst="line">
            <a:avLst/>
          </a:prstGeom>
          <a:ln w="19050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58CAAFA3-FCAD-41CD-95E5-7E058F801A33}"/>
              </a:ext>
            </a:extLst>
          </p:cNvPr>
          <p:cNvSpPr/>
          <p:nvPr/>
        </p:nvSpPr>
        <p:spPr>
          <a:xfrm>
            <a:off x="2656871" y="3969612"/>
            <a:ext cx="363474" cy="230833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>
                <a:lumMod val="20000"/>
                <a:lumOff val="80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750" b="1" dirty="0">
                <a:latin typeface="Arial" panose="020B0604020202020204" pitchFamily="34" charset="0"/>
                <a:cs typeface="Arial" panose="020B0604020202020204" pitchFamily="34" charset="0"/>
              </a:rPr>
              <a:t>0.4% NaCl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F0100482-A2D0-4E0D-8F04-B78E820BC466}"/>
              </a:ext>
            </a:extLst>
          </p:cNvPr>
          <p:cNvSpPr/>
          <p:nvPr/>
        </p:nvSpPr>
        <p:spPr>
          <a:xfrm>
            <a:off x="3059424" y="3969612"/>
            <a:ext cx="1776563" cy="230833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solidFill>
              <a:schemeClr val="bg2">
                <a:lumMod val="90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750" b="1" dirty="0">
                <a:latin typeface="Arial" panose="020B0604020202020204" pitchFamily="34" charset="0"/>
                <a:cs typeface="Arial" panose="020B0604020202020204" pitchFamily="34" charset="0"/>
              </a:rPr>
              <a:t>4% NaC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839FEDA-C649-4664-927E-392A865B31D8}"/>
              </a:ext>
            </a:extLst>
          </p:cNvPr>
          <p:cNvSpPr txBox="1"/>
          <p:nvPr/>
        </p:nvSpPr>
        <p:spPr>
          <a:xfrm>
            <a:off x="792480" y="6599000"/>
            <a:ext cx="5493382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 Effect of BTTQ on systolic and diastolic blood pressure of Dahl SS rats. SS rats were dosed twice daily with BTTQ (3 mg/kg) through oral gavage.  (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) Systolic and (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) diastolic pressure were recorded with telemetry for 5 days on a normal salt diet (0.4%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NaCl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) and 21 days after switching the animals to a high salt diet (4%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NaCl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). Data represented as mean ± SEM.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1D0F1B9-2570-432F-8FB4-B2D792D7C9B0}"/>
              </a:ext>
            </a:extLst>
          </p:cNvPr>
          <p:cNvSpPr txBox="1"/>
          <p:nvPr/>
        </p:nvSpPr>
        <p:spPr>
          <a:xfrm>
            <a:off x="1887494" y="397877"/>
            <a:ext cx="268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8D8AB53-C154-4C95-82E0-C7312102497B}"/>
              </a:ext>
            </a:extLst>
          </p:cNvPr>
          <p:cNvSpPr txBox="1"/>
          <p:nvPr/>
        </p:nvSpPr>
        <p:spPr>
          <a:xfrm>
            <a:off x="1911007" y="3359463"/>
            <a:ext cx="268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954568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839FEDA-C649-4664-927E-392A865B31D8}"/>
              </a:ext>
            </a:extLst>
          </p:cNvPr>
          <p:cNvSpPr txBox="1"/>
          <p:nvPr/>
        </p:nvSpPr>
        <p:spPr>
          <a:xfrm>
            <a:off x="682309" y="6185899"/>
            <a:ext cx="5493382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Effect of combined BTTQ and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enalapril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therapy on systolic and diastolic blood pressure of SHR rats. SHR rats were dosed twice daily and (A) systolic and (B) diastolic blood pressure were recorded for 24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hrs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with telemetry.  Dotted line represents the timing of doses.  All the data represented as mean ± SEM. All the data represented as mean ± SEM. Main effect of BTTQ + Enalapril treated animals is significantly different from enalapril alone, p&lt;0.005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7432472-A735-4004-83C6-4E656BD664A2}"/>
              </a:ext>
            </a:extLst>
          </p:cNvPr>
          <p:cNvSpPr txBox="1"/>
          <p:nvPr/>
        </p:nvSpPr>
        <p:spPr>
          <a:xfrm>
            <a:off x="938477" y="673299"/>
            <a:ext cx="268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33B581E-5F21-4A49-A558-932141EECEA4}"/>
              </a:ext>
            </a:extLst>
          </p:cNvPr>
          <p:cNvSpPr txBox="1"/>
          <p:nvPr/>
        </p:nvSpPr>
        <p:spPr>
          <a:xfrm>
            <a:off x="935864" y="3595698"/>
            <a:ext cx="268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FF7CDC12-0319-4B7E-9647-5C5B4E7EEC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5540822"/>
              </p:ext>
            </p:extLst>
          </p:nvPr>
        </p:nvGraphicFramePr>
        <p:xfrm>
          <a:off x="1069976" y="3595698"/>
          <a:ext cx="5014914" cy="24873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2" name="Prism 8" r:id="rId3" imgW="7010042" imgH="3421888" progId="Prism8.Document">
                  <p:embed/>
                </p:oleObj>
              </mc:Choice>
              <mc:Fallback>
                <p:oleObj name="Prism 8" r:id="rId3" imgW="7010042" imgH="3421888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FF7CDC12-0319-4B7E-9647-5C5B4E7EEC8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69976" y="3595698"/>
                        <a:ext cx="5014914" cy="24873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8D2607CB-1C22-405B-8B13-EFB94341B5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6972874"/>
              </p:ext>
            </p:extLst>
          </p:nvPr>
        </p:nvGraphicFramePr>
        <p:xfrm>
          <a:off x="1069976" y="673299"/>
          <a:ext cx="5011737" cy="2487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3" name="Prism 8" r:id="rId5" imgW="7006800" imgH="3421888" progId="Prism8.Document">
                  <p:embed/>
                </p:oleObj>
              </mc:Choice>
              <mc:Fallback>
                <p:oleObj name="Prism 8" r:id="rId5" imgW="7006800" imgH="3421888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8D2607CB-1C22-405B-8B13-EFB94341B5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069976" y="673299"/>
                        <a:ext cx="5011737" cy="2487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038101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40F454E-D69D-4BF9-93FA-4336E96B7DBE}"/>
              </a:ext>
            </a:extLst>
          </p:cNvPr>
          <p:cNvSpPr txBox="1"/>
          <p:nvPr/>
        </p:nvSpPr>
        <p:spPr>
          <a:xfrm>
            <a:off x="585090" y="7015576"/>
            <a:ext cx="549338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.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Expression of PDE1 in the different parts of the cardiovascular system of SS rats, and kidney of Sprague Dawley rats (positive control). </a:t>
            </a:r>
          </a:p>
        </p:txBody>
      </p:sp>
      <p:pic>
        <p:nvPicPr>
          <p:cNvPr id="4" name="Picture 3" descr="A picture containing guitar&#10;&#10;Description automatically generated">
            <a:extLst>
              <a:ext uri="{FF2B5EF4-FFF2-40B4-BE49-F238E27FC236}">
                <a16:creationId xmlns:a16="http://schemas.microsoft.com/office/drawing/2014/main" id="{CF4E6FCA-A429-4185-AD47-42A297C70F6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-394" b="-1"/>
          <a:stretch/>
        </p:blipFill>
        <p:spPr>
          <a:xfrm>
            <a:off x="2556933" y="1060192"/>
            <a:ext cx="1744134" cy="404992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B096839-268D-48E8-805D-4C85D2379F8C}"/>
              </a:ext>
            </a:extLst>
          </p:cNvPr>
          <p:cNvSpPr txBox="1"/>
          <p:nvPr/>
        </p:nvSpPr>
        <p:spPr>
          <a:xfrm rot="16200000">
            <a:off x="1515654" y="6282584"/>
            <a:ext cx="2624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4C9C9BF-1BEC-473F-8012-E10ACF1F94C7}"/>
              </a:ext>
            </a:extLst>
          </p:cNvPr>
          <p:cNvSpPr txBox="1"/>
          <p:nvPr/>
        </p:nvSpPr>
        <p:spPr>
          <a:xfrm rot="16200000">
            <a:off x="1912755" y="6280439"/>
            <a:ext cx="2624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ort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46F1EF5-4006-4091-B4DE-091020BD4D57}"/>
              </a:ext>
            </a:extLst>
          </p:cNvPr>
          <p:cNvSpPr txBox="1"/>
          <p:nvPr/>
        </p:nvSpPr>
        <p:spPr>
          <a:xfrm rot="16200000">
            <a:off x="2367775" y="6283456"/>
            <a:ext cx="2624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Mesenteric artery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7F17A07-BEE5-483B-B671-5F5D30E24CC2}"/>
              </a:ext>
            </a:extLst>
          </p:cNvPr>
          <p:cNvSpPr txBox="1"/>
          <p:nvPr/>
        </p:nvSpPr>
        <p:spPr>
          <a:xfrm rot="16200000">
            <a:off x="2736381" y="6268561"/>
            <a:ext cx="2624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6924146B-949A-4BAE-8F67-0BEF1B8533B5}"/>
              </a:ext>
            </a:extLst>
          </p:cNvPr>
          <p:cNvCxnSpPr/>
          <p:nvPr/>
        </p:nvCxnSpPr>
        <p:spPr>
          <a:xfrm>
            <a:off x="2569812" y="963053"/>
            <a:ext cx="127706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371231D3-E89B-4806-9C69-9D4EE7A21283}"/>
              </a:ext>
            </a:extLst>
          </p:cNvPr>
          <p:cNvSpPr txBox="1"/>
          <p:nvPr/>
        </p:nvSpPr>
        <p:spPr>
          <a:xfrm>
            <a:off x="2304580" y="655276"/>
            <a:ext cx="1744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SS rat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5ECDC2E-DABF-4773-96A9-EA5D92C98717}"/>
              </a:ext>
            </a:extLst>
          </p:cNvPr>
          <p:cNvSpPr txBox="1"/>
          <p:nvPr/>
        </p:nvSpPr>
        <p:spPr>
          <a:xfrm>
            <a:off x="3302364" y="658692"/>
            <a:ext cx="1744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SD rat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B24F8173-FD4D-4458-B273-D41BB36871F4}"/>
              </a:ext>
            </a:extLst>
          </p:cNvPr>
          <p:cNvCxnSpPr>
            <a:cxnSpLocks/>
          </p:cNvCxnSpPr>
          <p:nvPr/>
        </p:nvCxnSpPr>
        <p:spPr>
          <a:xfrm>
            <a:off x="3913876" y="961038"/>
            <a:ext cx="406241" cy="572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2CBA87DF-A5F7-4EAF-B34F-FE5C34F1639C}"/>
              </a:ext>
            </a:extLst>
          </p:cNvPr>
          <p:cNvCxnSpPr>
            <a:cxnSpLocks/>
          </p:cNvCxnSpPr>
          <p:nvPr/>
        </p:nvCxnSpPr>
        <p:spPr>
          <a:xfrm>
            <a:off x="3876201" y="541019"/>
            <a:ext cx="12880" cy="4580974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Isosceles Triangle 13">
            <a:extLst>
              <a:ext uri="{FF2B5EF4-FFF2-40B4-BE49-F238E27FC236}">
                <a16:creationId xmlns:a16="http://schemas.microsoft.com/office/drawing/2014/main" id="{77650C16-1BAC-445F-96A1-435867FC9EAC}"/>
              </a:ext>
            </a:extLst>
          </p:cNvPr>
          <p:cNvSpPr/>
          <p:nvPr/>
        </p:nvSpPr>
        <p:spPr>
          <a:xfrm rot="16200000">
            <a:off x="4389095" y="2653325"/>
            <a:ext cx="163132" cy="237709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40822C5-F582-4452-A4C4-66AE93778ED2}"/>
              </a:ext>
            </a:extLst>
          </p:cNvPr>
          <p:cNvSpPr txBox="1"/>
          <p:nvPr/>
        </p:nvSpPr>
        <p:spPr>
          <a:xfrm>
            <a:off x="4553522" y="2640218"/>
            <a:ext cx="11462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PDE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2B1D2E1-0A86-456A-8C17-C0EE1E153994}"/>
              </a:ext>
            </a:extLst>
          </p:cNvPr>
          <p:cNvSpPr/>
          <p:nvPr/>
        </p:nvSpPr>
        <p:spPr>
          <a:xfrm>
            <a:off x="2268355" y="2049356"/>
            <a:ext cx="282498" cy="65743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873AAC2-F185-40CC-A9C1-31C7015015B0}"/>
              </a:ext>
            </a:extLst>
          </p:cNvPr>
          <p:cNvSpPr txBox="1"/>
          <p:nvPr/>
        </p:nvSpPr>
        <p:spPr>
          <a:xfrm>
            <a:off x="1176172" y="1913585"/>
            <a:ext cx="11462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GB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23C18DF-E80D-40B7-9B7A-517DD5E77F39}"/>
              </a:ext>
            </a:extLst>
          </p:cNvPr>
          <p:cNvSpPr txBox="1"/>
          <p:nvPr/>
        </p:nvSpPr>
        <p:spPr>
          <a:xfrm>
            <a:off x="1176172" y="2700138"/>
            <a:ext cx="11462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GB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8C754777-C408-411F-8B72-DA17C821EC0C}"/>
              </a:ext>
            </a:extLst>
          </p:cNvPr>
          <p:cNvSpPr/>
          <p:nvPr/>
        </p:nvSpPr>
        <p:spPr>
          <a:xfrm>
            <a:off x="2268355" y="2820874"/>
            <a:ext cx="282498" cy="65743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8618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362746"/>
              </p:ext>
            </p:extLst>
          </p:nvPr>
        </p:nvGraphicFramePr>
        <p:xfrm>
          <a:off x="1375194" y="2259874"/>
          <a:ext cx="4119293" cy="28477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4" name="Prism 8" r:id="rId3" imgW="4065932" imgH="2808481" progId="Prism8.Document">
                  <p:embed/>
                </p:oleObj>
              </mc:Choice>
              <mc:Fallback>
                <p:oleObj name="Prism 8" r:id="rId3" imgW="4065932" imgH="2808481" progId="Prism8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75194" y="2259874"/>
                        <a:ext cx="4119293" cy="28477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265737" y="75757"/>
            <a:ext cx="556563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Figure 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839FEDA-C649-4664-927E-392A865B31D8}"/>
              </a:ext>
            </a:extLst>
          </p:cNvPr>
          <p:cNvSpPr txBox="1"/>
          <p:nvPr/>
        </p:nvSpPr>
        <p:spPr>
          <a:xfrm>
            <a:off x="625159" y="5724234"/>
            <a:ext cx="549338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.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Concentration-response curve showing the percent of relaxation of pre-constricted third order mesenteric artery from SS rats that were on high salt diet (4%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NaCl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) for 21 days and dosed twice per day with BTTQ through oral gavage in response to varying concentrations of acetylcholine. Data represent mean ± SEM.</a:t>
            </a:r>
          </a:p>
        </p:txBody>
      </p:sp>
    </p:spTree>
    <p:extLst>
      <p:ext uri="{BB962C8B-B14F-4D97-AF65-F5344CB8AC3E}">
        <p14:creationId xmlns:p14="http://schemas.microsoft.com/office/powerpoint/2010/main" val="38697059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5E60F9E2D615149A61D02D009C28034" ma:contentTypeVersion="10" ma:contentTypeDescription="Create a new document." ma:contentTypeScope="" ma:versionID="4c1d89eee4314bf014c97891f4f1b086">
  <xsd:schema xmlns:xsd="http://www.w3.org/2001/XMLSchema" xmlns:xs="http://www.w3.org/2001/XMLSchema" xmlns:p="http://schemas.microsoft.com/office/2006/metadata/properties" xmlns:ns3="7d4822ec-2ced-48b9-b184-377e31a10ba7" targetNamespace="http://schemas.microsoft.com/office/2006/metadata/properties" ma:root="true" ma:fieldsID="0282fec20c7368dd1ed3659c8639fcdd" ns3:_="">
    <xsd:import namespace="7d4822ec-2ced-48b9-b184-377e31a10ba7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3:MediaServiceAutoKeyPoints" minOccurs="0"/>
                <xsd:element ref="ns3:MediaServiceKeyPoints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d4822ec-2ced-48b9-b184-377e31a10ba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Location" ma:internalName="MediaServiceLocation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35611AAE-D0C9-4CAF-8FB6-E38E4EE95636}">
  <ds:schemaRefs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2006/documentManagement/types"/>
    <ds:schemaRef ds:uri="http://purl.org/dc/elements/1.1/"/>
    <ds:schemaRef ds:uri="http://schemas.microsoft.com/office/infopath/2007/PartnerControls"/>
    <ds:schemaRef ds:uri="7d4822ec-2ced-48b9-b184-377e31a10ba7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64F31ECB-5F2B-4B39-B5F0-0046D5A3EA4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d4822ec-2ced-48b9-b184-377e31a10ba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8F36FEB0-17A4-4CC5-9CBA-24BB5A2D9FE8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65</TotalTime>
  <Words>435</Words>
  <Application>Microsoft Office PowerPoint</Application>
  <PresentationFormat>On-screen Show (4:3)</PresentationFormat>
  <Paragraphs>28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aruschenko, Alexander</dc:creator>
  <cp:lastModifiedBy>Asim Bikash Dey</cp:lastModifiedBy>
  <cp:revision>31</cp:revision>
  <cp:lastPrinted>2020-02-12T17:27:55Z</cp:lastPrinted>
  <dcterms:created xsi:type="dcterms:W3CDTF">2019-05-15T21:55:15Z</dcterms:created>
  <dcterms:modified xsi:type="dcterms:W3CDTF">2020-06-29T19:43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5E60F9E2D615149A61D02D009C28034</vt:lpwstr>
  </property>
</Properties>
</file>